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0493"/>
  </p:normalViewPr>
  <p:slideViewPr>
    <p:cSldViewPr snapToGrid="0" snapToObjects="1">
      <p:cViewPr varScale="1">
        <p:scale>
          <a:sx n="104" d="100"/>
          <a:sy n="104" d="100"/>
        </p:scale>
        <p:origin x="14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21A7BF-85C7-4540-A8EF-F51B04EAFFF1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01A89C-CB3E-9144-9A60-33921546439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71690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01A89C-CB3E-9144-9A60-339215464397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5501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B7BF39-0E27-5146-AB39-6F9EAB4205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08CFBE1-6021-3147-992A-8C66A2492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9E2D2E-F96E-E242-A3C8-49951FDD5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1BE31C-3C23-1A4E-9D58-BB8CD8872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6F3833-A1BB-2940-A2E3-5832A3BA3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99609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C24F1B-B560-664B-A15F-CB36EFB26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3602EDF-5401-5B47-9063-8496ECEF86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21BBA9-3592-D649-AD2E-AED44FE84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776BFE-9FA2-CC43-B5D3-D2C6C882A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F7340-8735-6A46-9D9B-ABE9289FF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93384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9874918-6B83-454C-B421-98E54277C1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AB73203-1541-7741-ABE0-6CA94B455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2166F4-5763-9949-8520-DB3320E9F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E2EB90-2E0E-2A49-8960-8EC2BBC1D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DB333A-09D7-284A-A36C-15C25A2BF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70098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7356E9-9B53-5A4C-9401-823B20EE7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FA4D85-5D37-C64F-B755-56CE5A0495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82CF07-04B3-CF47-89AC-FFD7DF524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338A21-BABF-B04E-8395-ECD372304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0EAA8B-CB47-4A48-9C17-198BF72C6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1764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5708DF-6568-3C4D-B74E-6790F0BCE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0BA060-67DF-8A42-ACB9-6319BBD7CF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3CBC19-3BE2-A740-AA8A-EEFAF6842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8C118B-B67F-C046-AC22-AE195CD28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0CF4B0-E565-734D-B961-E438576E5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24077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DCCD08-3141-6C46-A653-C6862FC829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79B4131-B64F-3B42-B984-1C24F4BFBD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B529F-672F-BF46-813E-5611AE296C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ABC408A-0046-8F42-BAEE-308C0B547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B17D60-64FA-AB4B-9417-85C12F550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7CB0BB-8E00-3147-8ECD-0B4C00B72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30545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A2945C-0FD6-094E-A50C-B199CDB59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389D69-E93D-814F-9C0F-3ABC269249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8515E10-163E-774B-9F11-6F43E2AF9D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022E0AA-0585-9C44-AEE0-6945550D1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EAE19B3-0B36-6048-8B68-D763EC2463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E172576-9001-804C-B693-38EE5C05C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CB834E8-E047-2447-92D8-B8338802D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9D30551-6BD7-6345-9D95-7C4821739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80713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840B0E-393D-974F-9CAA-7196E09BA4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E8A3818-FB49-434B-97DE-D5625032F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D16E3B-5CFD-8240-B720-55C6E40A6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8DDE62D-54CF-BD46-8A9C-D3A5EBD22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55292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5128F2C-6E28-8E4C-80FB-369705891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8C43B7E-DBD8-344F-801B-299E82635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2534377-7B01-7A41-83AE-6AD249955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88824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E937F3-34E2-1B49-998B-4801C1462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8B7C29-714E-974C-AB33-D6365B505E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2CC1A1F-E9AE-1F4F-ACB2-B54F6FE999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859750B-9D59-404E-9726-F554EF7DD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241251D-E22C-D343-84DB-0A3DEEEE0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0905DF-A47B-714C-8849-48B34DF30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9950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539BB4-4BEA-8D43-8A30-AE1B11572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0913EE8-9326-9740-994C-54CCA63B0C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A3B10B-8A08-6F45-A666-3E3386051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7A244D-4233-9442-84D0-7EF3C728B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E63A5B0-38E8-6C4E-A45F-FE0BA261A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B52A065-D958-6D42-84C8-BCE1566A7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15673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4271F09-2479-D74D-91BC-09502BEBB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AF9F61F-B695-1A41-AD10-CC6BAE188E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892249-58A8-8942-85AC-0FFBC7DE7E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2DD3A-DC73-E24A-A489-E55E05B955A2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23DAF-0F30-3D47-B1DE-CB0048BD77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37EED1-6502-3146-BBF6-09C25993B6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C0C13-DF8C-A547-8620-4A8AA3C1F33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748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8F1E8169-D38A-9244-B9A8-05E457763D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3020602" y="323637"/>
            <a:ext cx="6534363" cy="6534363"/>
          </a:xfr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7DD90C0-094B-EB4A-9A4D-53E141DA20A7}"/>
              </a:ext>
            </a:extLst>
          </p:cNvPr>
          <p:cNvSpPr txBox="1"/>
          <p:nvPr/>
        </p:nvSpPr>
        <p:spPr>
          <a:xfrm>
            <a:off x="3020602" y="5373300"/>
            <a:ext cx="65343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altLang="zh-CN" sz="1200" b="1" kern="1200" dirty="0">
                <a:solidFill>
                  <a:schemeClr val="tx1"/>
                </a:solidFill>
                <a:effectLst/>
                <a:latin typeface="Times" pitchFamily="2" charset="0"/>
              </a:rPr>
              <a:t>Venn Diagram analysis of commonly expressed, and uniquely expressed genes in groups A and B </a:t>
            </a:r>
            <a:endParaRPr kumimoji="1" lang="zh-CN" altLang="en-US" sz="1200" b="1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0285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7</Words>
  <Application>Microsoft Macintosh PowerPoint</Application>
  <PresentationFormat>宽屏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red win</dc:creator>
  <cp:lastModifiedBy>fred win</cp:lastModifiedBy>
  <cp:revision>4</cp:revision>
  <dcterms:created xsi:type="dcterms:W3CDTF">2022-08-08T07:34:42Z</dcterms:created>
  <dcterms:modified xsi:type="dcterms:W3CDTF">2022-08-22T22:50:00Z</dcterms:modified>
</cp:coreProperties>
</file>